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274" r:id="rId2"/>
    <p:sldId id="261" r:id="rId3"/>
    <p:sldId id="262" r:id="rId4"/>
    <p:sldId id="263" r:id="rId5"/>
    <p:sldId id="264" r:id="rId6"/>
    <p:sldId id="265" r:id="rId7"/>
    <p:sldId id="266" r:id="rId8"/>
    <p:sldId id="267" r:id="rId9"/>
    <p:sldId id="268" r:id="rId10"/>
    <p:sldId id="269" r:id="rId11"/>
    <p:sldId id="260" r:id="rId12"/>
    <p:sldId id="257" r:id="rId13"/>
    <p:sldId id="258" r:id="rId14"/>
    <p:sldId id="272" r:id="rId15"/>
    <p:sldId id="273" r:id="rId16"/>
    <p:sldId id="259" r:id="rId17"/>
    <p:sldId id="270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85EBD94-17A7-3BD4-29CA-7695AD311CC2}" name="Adeola Kosoko" initials="AK" userId="f6356b482bbbde8e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36" autoAdjust="0"/>
    <p:restoredTop sz="94660"/>
  </p:normalViewPr>
  <p:slideViewPr>
    <p:cSldViewPr snapToGrid="0">
      <p:cViewPr varScale="1">
        <p:scale>
          <a:sx n="60" d="100"/>
          <a:sy n="60" d="100"/>
        </p:scale>
        <p:origin x="96" y="1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microsoft.com/office/2018/10/relationships/authors" Target="author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D804C2-18BF-4E68-9CCD-6871A0D58FE3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2DA095-687B-4E6F-8219-E83C278F4D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2637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Google Shape;82;g10d66907d52_0_7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3" name="Google Shape;83;g10d66907d52_0_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g10d66907d52_0_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88" name="Google Shape;88;g10d66907d52_0_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50ACF6-5EB8-4B4C-A4DF-2CA9D84BB5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73F40C3-6BAE-44FC-A02F-8EE741B02F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534CB7-D32C-4737-8ECD-6F7EB3EC34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8909D7-DB3E-49CC-A334-B515FB973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AEFEE2-2B47-40A2-9ED1-600247343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31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08CC2C-1E8B-481F-A420-4562686AB8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631F4F-2596-4F0D-9519-BD9D5CD32E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14E240-1238-478F-8460-C76DE56D9F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CF013D-A94A-40B4-88ED-E53D00932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687031-7AFE-4667-9E6E-48A81C4728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701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AD1B26-61D1-4D55-BFEC-7D149A4FE5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277F0A-8AC0-4360-99D9-5D7ECEE60C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E78937-2D8A-4A95-83B4-9C88D07B05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DA50E0-E739-43AD-B490-5A2732780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4B5BB9-6345-4F55-95EA-EAB17E8DF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706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62CBC0-20FC-4523-AD28-1C7BDC884F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D96F87-3341-40D2-9E0F-64A206829ED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0A94EE-21F6-4514-8585-98C1C77F95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63E31D-7B52-432F-9C14-D64897946A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14F54C7-7E57-4802-815A-337A42F3C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1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B97BC2-6259-41B8-8F21-90D3650285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51711-DDAE-491D-9B84-A631BFCF72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EC8F4C-FDD7-4F36-9E6A-56716E43D0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F4309D-91EC-4ADE-A9EF-6870E2D2DA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91FE1-6670-48CD-8CD2-A8FE98BCB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937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34123D-39EF-42EF-A489-F8BF5E3B52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A04974-DB09-4BCC-8EA8-18601669AB5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74FCB38-3FB7-4A42-9AF0-EE66D571ED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D34BA1-B873-47A1-A21E-E5EFC5040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C1419FD-5C4B-4AD0-AC58-2F2EA4BCB6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672D8D-E6FD-4E55-9F8F-D24165F49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992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A82458-F507-409E-82C9-CF00982F2E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A5B523-FFDA-4FE8-A3B8-4167B16249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DEF46D-9FA4-40F0-BF4C-8143E4C25A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8D6D19-AC77-4E98-A142-472DDCDAA6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FAF7B3C-9934-4DB1-8679-4296005097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53A2AD2-DCE6-4CAA-8A2B-68BBFE2053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E7E890-877F-4FB4-B5E1-FF279711C0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B42D674-6A6E-4781-B089-6B90E31B73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3680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6A2984-0671-497A-9F5A-9EF1C9F930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C02D56E-B557-4411-9D33-B706B1259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FB734F5-BB1F-4AF1-8F3C-0BEB894FD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665DF9-37B4-455C-9ED0-F61FC645CB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9457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88EB6BF-1457-4D90-A82F-095A9FC249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AAC98D4-0AAE-4CF1-8898-81BF2EEB5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08F676-484C-4574-BAD4-71B30677C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887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013570-7075-4603-8841-22DE08F36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A82D31-A0C2-44A6-AAC4-E8D1E1429D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0EBDD50-A87B-4E8D-9C8F-50346B6E13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8A52EA-F6DE-47AF-A970-9D5EE56F0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BD8F28-F3A5-475D-BAF5-3D47C01D6B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3B694E-543A-4D85-B47A-EF9C533255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6222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754603-5947-4EBF-B12A-B265B33F05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434DF6D-C475-4F04-971E-24DF7C82A8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190B296-8D20-4C7F-9A88-B4FBAFA10E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D0BCC-EEBD-4C3A-A662-7B111F5B5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FACF70-55FD-4E55-ADD9-7850EA37BE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C7135E-2194-4018-B7D1-09542FF06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159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FB07047-98BC-4741-9DE7-8564993E05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D455FD-E732-4568-8437-A9DE558C73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3CCA24-0224-41A1-8B35-7691368BDD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9D3B02-4820-489F-AA6C-16FE9E59373D}" type="datetimeFigureOut">
              <a:rPr lang="en-US" smtClean="0"/>
              <a:t>4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42AB42-21AF-41B4-AB95-6703EC2686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7DC267-8B46-4243-973A-F249154931D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6AFBD-9D72-40D6-94C3-37D1DB4379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877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hyperlink" Target="http://drive.google.com/file/d/1fFOnGeOEk8jLTCKBfVb0aTNCM9KX84PD/view" TargetMode="External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hyperlink" Target="http://drive.google.com/file/d/1pMKdmSPzXxziCDXPwTpbjdsRjCV_Dcmt/view" TargetMode="Externa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hyperlink" Target="http://drive.google.com/file/d/1tT1_OQzgpkVovkawET416sN6xCPXxFNH/view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219EAC-FE8F-47B8-A237-ADADE4EB556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Stimulus Material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D0614D-B45A-4040-97DE-8EC3BD0D88E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49002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BAF10C0-64C9-4D78-8301-7D66F94D5B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6758958"/>
              </p:ext>
            </p:extLst>
          </p:nvPr>
        </p:nvGraphicFramePr>
        <p:xfrm>
          <a:off x="3037115" y="502920"/>
          <a:ext cx="5791201" cy="5852160"/>
        </p:xfrm>
        <a:graphic>
          <a:graphicData uri="http://schemas.openxmlformats.org/drawingml/2006/table">
            <a:tbl>
              <a:tblPr firstRow="1" firstCol="1" bandRow="1"/>
              <a:tblGrid>
                <a:gridCol w="3040669">
                  <a:extLst>
                    <a:ext uri="{9D8B030D-6E8A-4147-A177-3AD203B41FA5}">
                      <a16:colId xmlns:a16="http://schemas.microsoft.com/office/drawing/2014/main" val="310790649"/>
                    </a:ext>
                  </a:extLst>
                </a:gridCol>
                <a:gridCol w="2750532">
                  <a:extLst>
                    <a:ext uri="{9D8B030D-6E8A-4147-A177-3AD203B41FA5}">
                      <a16:colId xmlns:a16="http://schemas.microsoft.com/office/drawing/2014/main" val="3351051785"/>
                    </a:ext>
                  </a:extLst>
                </a:gridCol>
              </a:tblGrid>
              <a:tr h="201930">
                <a:tc gridSpan="2">
                  <a:txBody>
                    <a:bodyPr/>
                    <a:lstStyle/>
                    <a:p>
                      <a:pPr marL="0" marR="0" algn="ctr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Urinalysis (UA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36476419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Color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Yellow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6025171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Appearanc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Clear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1036183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Specific Gravity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.01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6579442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pH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7.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5858070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Glucos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8321823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Bilirubin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6654296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Ketones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5622109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Protein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+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9176302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Leukocyte esteras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+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5714890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Nitrites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3617755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hite blood cells (WBC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 WBCs/high powered field (HPF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8486332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Red blood cells (RBC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0 RBCs/HPF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2977649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Squamous epithelial cells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Times New Roman" panose="02020603050405020304" pitchFamily="18" charset="0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0-5 cells/HPF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34151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032249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D467AB68-A1F4-4761-81EC-ACB6960E135D}"/>
              </a:ext>
            </a:extLst>
          </p:cNvPr>
          <p:cNvSpPr txBox="1"/>
          <p:nvPr/>
        </p:nvSpPr>
        <p:spPr>
          <a:xfrm>
            <a:off x="5010605" y="6549053"/>
            <a:ext cx="45516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uthor’s Own Image</a:t>
            </a:r>
          </a:p>
        </p:txBody>
      </p:sp>
      <p:pic>
        <p:nvPicPr>
          <p:cNvPr id="4" name="Picture 3" descr="https://lh4.googleusercontent.com/j-6w074z9O8Q9jjMaxE_qWWj3_bczKm7ZntNgDmyHjVLQgOaIeYMp_Z2kw4PpiQ4a0wVBjrqnizoDNOQRAv0LPOJdaeK2ydgJTEuUlRD4n59gGdbwNJLCPQodpRWXcBdlkd6_TfnBFpJ">
            <a:extLst>
              <a:ext uri="{FF2B5EF4-FFF2-40B4-BE49-F238E27FC236}">
                <a16:creationId xmlns:a16="http://schemas.microsoft.com/office/drawing/2014/main" id="{7D310028-19BF-44B3-BF50-8D906D70D775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9" t="2602" r="4622" b="58863"/>
          <a:stretch/>
        </p:blipFill>
        <p:spPr bwMode="auto">
          <a:xfrm>
            <a:off x="957532" y="720513"/>
            <a:ext cx="9701374" cy="5267823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403911387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6A4F024-3664-49F9-B3BA-3191DAB0F101}"/>
              </a:ext>
            </a:extLst>
          </p:cNvPr>
          <p:cNvSpPr txBox="1"/>
          <p:nvPr/>
        </p:nvSpPr>
        <p:spPr>
          <a:xfrm>
            <a:off x="4768491" y="6581775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uthor’s Own Image</a:t>
            </a:r>
          </a:p>
        </p:txBody>
      </p:sp>
      <p:pic>
        <p:nvPicPr>
          <p:cNvPr id="4" name="Picture 3" descr="posttestQ2pulmonaryedema">
            <a:extLst>
              <a:ext uri="{FF2B5EF4-FFF2-40B4-BE49-F238E27FC236}">
                <a16:creationId xmlns:a16="http://schemas.microsoft.com/office/drawing/2014/main" id="{228EC112-7F7D-4AD3-8B24-9DF4DA5B3131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43225" y="276225"/>
            <a:ext cx="6305550" cy="630555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59048337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2C4DDAE-D261-4479-84D7-35F8CC91B66B}"/>
              </a:ext>
            </a:extLst>
          </p:cNvPr>
          <p:cNvSpPr txBox="1"/>
          <p:nvPr/>
        </p:nvSpPr>
        <p:spPr>
          <a:xfrm>
            <a:off x="4924927" y="648866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uthor’s Own Image</a:t>
            </a:r>
          </a:p>
        </p:txBody>
      </p:sp>
      <p:pic>
        <p:nvPicPr>
          <p:cNvPr id="5" name="Google Shape;80;p17" title="21.25.53 hrs __[0001295].mp4">
            <a:hlinkClick r:id="rId2"/>
            <a:extLst>
              <a:ext uri="{FF2B5EF4-FFF2-40B4-BE49-F238E27FC236}">
                <a16:creationId xmlns:a16="http://schemas.microsoft.com/office/drawing/2014/main" id="{CC9DD684-A32C-41CD-882A-C57651BDED4E}"/>
              </a:ext>
            </a:extLst>
          </p:cNvPr>
          <p:cNvPicPr preferRelativeResize="0"/>
          <p:nvPr/>
        </p:nvPicPr>
        <p:blipFill rotWithShape="1">
          <a:blip r:embed="rId3">
            <a:alphaModFix/>
          </a:blip>
          <a:srcRect t="5325"/>
          <a:stretch/>
        </p:blipFill>
        <p:spPr>
          <a:xfrm>
            <a:off x="2128133" y="611560"/>
            <a:ext cx="7935733" cy="563487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08893459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Google Shape;85;p18" title="21.21.43 hrs __[0001289].mp4">
            <a:hlinkClick r:id="rId3"/>
          </p:cNvPr>
          <p:cNvPicPr preferRelativeResize="0"/>
          <p:nvPr/>
        </p:nvPicPr>
        <p:blipFill rotWithShape="1">
          <a:blip r:embed="rId4">
            <a:alphaModFix/>
          </a:blip>
          <a:srcRect t="5249"/>
          <a:stretch/>
        </p:blipFill>
        <p:spPr>
          <a:xfrm>
            <a:off x="1976744" y="485273"/>
            <a:ext cx="8238512" cy="5887453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17C7434-364B-4A1E-B4E1-16AF947B0B16}"/>
              </a:ext>
            </a:extLst>
          </p:cNvPr>
          <p:cNvSpPr txBox="1"/>
          <p:nvPr/>
        </p:nvSpPr>
        <p:spPr>
          <a:xfrm>
            <a:off x="4924927" y="6488668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uthor’s Own Image</a:t>
            </a: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19" title="21.19.49 hrs __[0001287].mp4">
            <a:hlinkClick r:id="rId3"/>
          </p:cNvPr>
          <p:cNvPicPr preferRelativeResize="0"/>
          <p:nvPr/>
        </p:nvPicPr>
        <p:blipFill rotWithShape="1">
          <a:blip r:embed="rId4">
            <a:alphaModFix/>
          </a:blip>
          <a:srcRect t="4930"/>
          <a:stretch/>
        </p:blipFill>
        <p:spPr>
          <a:xfrm>
            <a:off x="2040912" y="438484"/>
            <a:ext cx="8110175" cy="5981031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42E6FC2-3875-40F6-AFAB-28F5A9EBCBC8}"/>
              </a:ext>
            </a:extLst>
          </p:cNvPr>
          <p:cNvSpPr txBox="1"/>
          <p:nvPr/>
        </p:nvSpPr>
        <p:spPr>
          <a:xfrm>
            <a:off x="4957012" y="6582246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uthor’s Own Image</a:t>
            </a: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92BFDDB-4064-4DB6-9BFE-4B43F6DBE98F}"/>
              </a:ext>
            </a:extLst>
          </p:cNvPr>
          <p:cNvSpPr txBox="1"/>
          <p:nvPr/>
        </p:nvSpPr>
        <p:spPr>
          <a:xfrm>
            <a:off x="5092460" y="6557383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uthor’s Own Imag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C747E7EC-2AB7-43C6-AF77-60CB1CCF366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969895" y="609600"/>
            <a:ext cx="6252210" cy="563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443795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E01F5D-A5DA-4848-9074-2862825B35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ardiotocography</a:t>
            </a:r>
          </a:p>
        </p:txBody>
      </p:sp>
      <p:pic>
        <p:nvPicPr>
          <p:cNvPr id="3" name="Picture 2" descr="https://lh5.googleusercontent.com/N8i70lqLvjZGAo8oe6NiEm2TD0fTFqRUDG8MJyMJ_SQejWukHFETZsLhNyEPxNfThGXv75CMiEE2oaeLcV8eBlJLKF8scZ096ZK3tmy8NIDTh0IlqyiN6ZsFcs_XK9JJSxdHrwRJq97d">
            <a:extLst>
              <a:ext uri="{FF2B5EF4-FFF2-40B4-BE49-F238E27FC236}">
                <a16:creationId xmlns:a16="http://schemas.microsoft.com/office/drawing/2014/main" id="{FC6595F5-032C-4639-91AC-B13F3D6733F5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346" b="11820"/>
          <a:stretch/>
        </p:blipFill>
        <p:spPr bwMode="auto">
          <a:xfrm>
            <a:off x="1656271" y="1997602"/>
            <a:ext cx="8617046" cy="2862796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89B3B8F-3594-4D44-9519-AB626063FD91}"/>
              </a:ext>
            </a:extLst>
          </p:cNvPr>
          <p:cNvSpPr txBox="1"/>
          <p:nvPr/>
        </p:nvSpPr>
        <p:spPr>
          <a:xfrm>
            <a:off x="4609381" y="6574635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Author’s Own Image</a:t>
            </a:r>
          </a:p>
        </p:txBody>
      </p:sp>
    </p:spTree>
    <p:extLst>
      <p:ext uri="{BB962C8B-B14F-4D97-AF65-F5344CB8AC3E}">
        <p14:creationId xmlns:p14="http://schemas.microsoft.com/office/powerpoint/2010/main" val="951148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5D84B8BE-25BD-4CD5-9296-AB8128B5591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42677176"/>
              </p:ext>
            </p:extLst>
          </p:nvPr>
        </p:nvGraphicFramePr>
        <p:xfrm>
          <a:off x="2699658" y="3276600"/>
          <a:ext cx="6232071" cy="365760"/>
        </p:xfrm>
        <a:graphic>
          <a:graphicData uri="http://schemas.openxmlformats.org/drawingml/2006/table">
            <a:tbl>
              <a:tblPr firstRow="1" firstCol="1" bandRow="1"/>
              <a:tblGrid>
                <a:gridCol w="3739243">
                  <a:extLst>
                    <a:ext uri="{9D8B030D-6E8A-4147-A177-3AD203B41FA5}">
                      <a16:colId xmlns:a16="http://schemas.microsoft.com/office/drawing/2014/main" val="2760141871"/>
                    </a:ext>
                  </a:extLst>
                </a:gridCol>
                <a:gridCol w="2492828">
                  <a:extLst>
                    <a:ext uri="{9D8B030D-6E8A-4147-A177-3AD203B41FA5}">
                      <a16:colId xmlns:a16="http://schemas.microsoft.com/office/drawing/2014/main" val="2485655859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int of Care- Glucos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3 mg/dL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45685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027376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7FE9EECC-3B21-4C79-9C85-C5F9352EC8F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6315242"/>
              </p:ext>
            </p:extLst>
          </p:nvPr>
        </p:nvGraphicFramePr>
        <p:xfrm>
          <a:off x="2362200" y="1756258"/>
          <a:ext cx="7467600" cy="3345484"/>
        </p:xfrm>
        <a:graphic>
          <a:graphicData uri="http://schemas.openxmlformats.org/drawingml/2006/table">
            <a:tbl>
              <a:tblPr firstRow="1" firstCol="1" bandRow="1"/>
              <a:tblGrid>
                <a:gridCol w="4480560">
                  <a:extLst>
                    <a:ext uri="{9D8B030D-6E8A-4147-A177-3AD203B41FA5}">
                      <a16:colId xmlns:a16="http://schemas.microsoft.com/office/drawing/2014/main" val="1084082644"/>
                    </a:ext>
                  </a:extLst>
                </a:gridCol>
                <a:gridCol w="2987040">
                  <a:extLst>
                    <a:ext uri="{9D8B030D-6E8A-4147-A177-3AD203B41FA5}">
                      <a16:colId xmlns:a16="http://schemas.microsoft.com/office/drawing/2014/main" val="1157798933"/>
                    </a:ext>
                  </a:extLst>
                </a:gridCol>
              </a:tblGrid>
              <a:tr h="482541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lete Blood Count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737893"/>
                  </a:ext>
                </a:extLst>
              </a:tr>
              <a:tr h="96508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White Blood Cel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 x 10</a:t>
                      </a:r>
                      <a:r>
                        <a:rPr lang="en-US" sz="2400" baseline="300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µ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417470"/>
                  </a:ext>
                </a:extLst>
              </a:tr>
              <a:tr h="4825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emoglobin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 g/d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0677472"/>
                  </a:ext>
                </a:extLst>
              </a:tr>
              <a:tr h="4825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ematocrit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36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2485646"/>
                  </a:ext>
                </a:extLst>
              </a:tr>
              <a:tr h="450239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latelets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0 x 10</a:t>
                      </a:r>
                      <a:r>
                        <a:rPr lang="en-US" sz="24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 µL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9941902"/>
                  </a:ext>
                </a:extLst>
              </a:tr>
              <a:tr h="48254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Differentia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nding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36271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095173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5DBC697-8029-4637-ADD1-0AEE002E6C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5834653"/>
              </p:ext>
            </p:extLst>
          </p:nvPr>
        </p:nvGraphicFramePr>
        <p:xfrm>
          <a:off x="2356756" y="868680"/>
          <a:ext cx="7222671" cy="5120640"/>
        </p:xfrm>
        <a:graphic>
          <a:graphicData uri="http://schemas.openxmlformats.org/drawingml/2006/table">
            <a:tbl>
              <a:tblPr firstRow="1" firstCol="1" bandRow="1"/>
              <a:tblGrid>
                <a:gridCol w="4333603">
                  <a:extLst>
                    <a:ext uri="{9D8B030D-6E8A-4147-A177-3AD203B41FA5}">
                      <a16:colId xmlns:a16="http://schemas.microsoft.com/office/drawing/2014/main" val="4216923111"/>
                    </a:ext>
                  </a:extLst>
                </a:gridCol>
                <a:gridCol w="2889068">
                  <a:extLst>
                    <a:ext uri="{9D8B030D-6E8A-4147-A177-3AD203B41FA5}">
                      <a16:colId xmlns:a16="http://schemas.microsoft.com/office/drawing/2014/main" val="905735931"/>
                    </a:ext>
                  </a:extLst>
                </a:gridCol>
              </a:tblGrid>
              <a:tr h="203200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mprehensive Metabolic Panel</a:t>
                      </a: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2898614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odium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0mEq/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4858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tassium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8 mEq/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213052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lorid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9 mEq/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30912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carbonat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 mEq/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566714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lucos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0 mg/d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480383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lood Urea Nitrogen (BUN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5 mg/d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365529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reatinin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9 mg/d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297311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lcium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.1 mg/d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22318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otal bilirubin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5 mg/d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545109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kaline phosphatas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0 units/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552598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spartate aminotransferase (AST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5 units/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380534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anine aminotransferase (ALT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5 units/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97925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lbumin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6g/dL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352113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872913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CCE4A6C-0076-4D18-9C7E-7D1D38132A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05723348"/>
              </p:ext>
            </p:extLst>
          </p:nvPr>
        </p:nvGraphicFramePr>
        <p:xfrm>
          <a:off x="3535135" y="1880904"/>
          <a:ext cx="5121729" cy="3096192"/>
        </p:xfrm>
        <a:graphic>
          <a:graphicData uri="http://schemas.openxmlformats.org/drawingml/2006/table">
            <a:tbl>
              <a:tblPr firstRow="1" firstCol="1" bandRow="1"/>
              <a:tblGrid>
                <a:gridCol w="2748643">
                  <a:extLst>
                    <a:ext uri="{9D8B030D-6E8A-4147-A177-3AD203B41FA5}">
                      <a16:colId xmlns:a16="http://schemas.microsoft.com/office/drawing/2014/main" val="4079382037"/>
                    </a:ext>
                  </a:extLst>
                </a:gridCol>
                <a:gridCol w="2373086">
                  <a:extLst>
                    <a:ext uri="{9D8B030D-6E8A-4147-A177-3AD203B41FA5}">
                      <a16:colId xmlns:a16="http://schemas.microsoft.com/office/drawing/2014/main" val="3331869604"/>
                    </a:ext>
                  </a:extLst>
                </a:gridCol>
              </a:tblGrid>
              <a:tr h="774048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Venous Blood Gas and Lactic Acid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5763632"/>
                  </a:ext>
                </a:extLst>
              </a:tr>
              <a:tr h="387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H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.35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2389870"/>
                  </a:ext>
                </a:extLst>
              </a:tr>
              <a:tr h="387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CO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 mmHg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15841849"/>
                  </a:ext>
                </a:extLst>
              </a:tr>
              <a:tr h="387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0 mmHg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9055232"/>
                  </a:ext>
                </a:extLst>
              </a:tr>
              <a:tr h="387024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HCO3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 mEq/L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7030600"/>
                  </a:ext>
                </a:extLst>
              </a:tr>
              <a:tr h="774048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actic Acid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.5 </a:t>
                      </a:r>
                      <a:r>
                        <a:rPr lang="en-US" sz="24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Eq</a:t>
                      </a: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L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9078622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753319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D0543DB1-3A04-4AC4-A4C3-794564A45E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0554613"/>
              </p:ext>
            </p:extLst>
          </p:nvPr>
        </p:nvGraphicFramePr>
        <p:xfrm>
          <a:off x="3135879" y="2166257"/>
          <a:ext cx="5920242" cy="2525486"/>
        </p:xfrm>
        <a:graphic>
          <a:graphicData uri="http://schemas.openxmlformats.org/drawingml/2006/table">
            <a:tbl>
              <a:tblPr firstRow="1" firstCol="1" bandRow="1"/>
              <a:tblGrid>
                <a:gridCol w="3883391">
                  <a:extLst>
                    <a:ext uri="{9D8B030D-6E8A-4147-A177-3AD203B41FA5}">
                      <a16:colId xmlns:a16="http://schemas.microsoft.com/office/drawing/2014/main" val="1656302722"/>
                    </a:ext>
                  </a:extLst>
                </a:gridCol>
                <a:gridCol w="2036851">
                  <a:extLst>
                    <a:ext uri="{9D8B030D-6E8A-4147-A177-3AD203B41FA5}">
                      <a16:colId xmlns:a16="http://schemas.microsoft.com/office/drawing/2014/main" val="3183509639"/>
                    </a:ext>
                  </a:extLst>
                </a:gridCol>
              </a:tblGrid>
              <a:tr h="505097">
                <a:tc gridSpan="2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agulopathy Panel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8344310"/>
                  </a:ext>
                </a:extLst>
              </a:tr>
              <a:tr h="75764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ternational Normalized Ratio (INR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14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5758127"/>
                  </a:ext>
                </a:extLst>
              </a:tr>
              <a:tr h="50509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rothrombin Time (PT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2.3 seconds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362779"/>
                  </a:ext>
                </a:extLst>
              </a:tr>
              <a:tr h="757646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tivated Partial Thomboplastin Time (aPTT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3.7 seconds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9624370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074251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86BD983-2113-4FA4-AE27-7892FD3593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3476203"/>
              </p:ext>
            </p:extLst>
          </p:nvPr>
        </p:nvGraphicFramePr>
        <p:xfrm>
          <a:off x="3309257" y="3246120"/>
          <a:ext cx="5372100" cy="365760"/>
        </p:xfrm>
        <a:graphic>
          <a:graphicData uri="http://schemas.openxmlformats.org/drawingml/2006/table">
            <a:tbl>
              <a:tblPr firstRow="1" firstCol="1" bandRow="1"/>
              <a:tblGrid>
                <a:gridCol w="3223260">
                  <a:extLst>
                    <a:ext uri="{9D8B030D-6E8A-4147-A177-3AD203B41FA5}">
                      <a16:colId xmlns:a16="http://schemas.microsoft.com/office/drawing/2014/main" val="2602840834"/>
                    </a:ext>
                  </a:extLst>
                </a:gridCol>
                <a:gridCol w="2148840">
                  <a:extLst>
                    <a:ext uri="{9D8B030D-6E8A-4147-A177-3AD203B41FA5}">
                      <a16:colId xmlns:a16="http://schemas.microsoft.com/office/drawing/2014/main" val="415101218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roponin - I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0 ng/mL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96266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792885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2048B47-7A03-4716-8CBC-917A78AE161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64564868"/>
              </p:ext>
            </p:extLst>
          </p:nvPr>
        </p:nvGraphicFramePr>
        <p:xfrm>
          <a:off x="2362201" y="3246120"/>
          <a:ext cx="7075714" cy="365760"/>
        </p:xfrm>
        <a:graphic>
          <a:graphicData uri="http://schemas.openxmlformats.org/drawingml/2006/table">
            <a:tbl>
              <a:tblPr firstRow="1" firstCol="1" bandRow="1"/>
              <a:tblGrid>
                <a:gridCol w="4641324">
                  <a:extLst>
                    <a:ext uri="{9D8B030D-6E8A-4147-A177-3AD203B41FA5}">
                      <a16:colId xmlns:a16="http://schemas.microsoft.com/office/drawing/2014/main" val="4027891725"/>
                    </a:ext>
                  </a:extLst>
                </a:gridCol>
                <a:gridCol w="2434390">
                  <a:extLst>
                    <a:ext uri="{9D8B030D-6E8A-4147-A177-3AD203B41FA5}">
                      <a16:colId xmlns:a16="http://schemas.microsoft.com/office/drawing/2014/main" val="845383537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rain Natiuretic Peptide (BNP)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8pg/mL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739836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615444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DA11E2A-958D-4B8E-AD73-8E0153DDB73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9649884"/>
              </p:ext>
            </p:extLst>
          </p:nvPr>
        </p:nvGraphicFramePr>
        <p:xfrm>
          <a:off x="4268787" y="3246120"/>
          <a:ext cx="3654425" cy="365760"/>
        </p:xfrm>
        <a:graphic>
          <a:graphicData uri="http://schemas.openxmlformats.org/drawingml/2006/table">
            <a:tbl>
              <a:tblPr firstRow="1" firstCol="1" bandRow="1"/>
              <a:tblGrid>
                <a:gridCol w="2397125">
                  <a:extLst>
                    <a:ext uri="{9D8B030D-6E8A-4147-A177-3AD203B41FA5}">
                      <a16:colId xmlns:a16="http://schemas.microsoft.com/office/drawing/2014/main" val="638833887"/>
                    </a:ext>
                  </a:extLst>
                </a:gridCol>
                <a:gridCol w="1257300">
                  <a:extLst>
                    <a:ext uri="{9D8B030D-6E8A-4147-A177-3AD203B41FA5}">
                      <a16:colId xmlns:a16="http://schemas.microsoft.com/office/drawing/2014/main" val="1479808494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rine Pregnancy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ositive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515809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764282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0</TotalTime>
  <Words>269</Words>
  <Application>Microsoft Office PowerPoint</Application>
  <PresentationFormat>Widescreen</PresentationFormat>
  <Paragraphs>100</Paragraphs>
  <Slides>17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3" baseType="lpstr">
      <vt:lpstr>MS Mincho</vt:lpstr>
      <vt:lpstr>Arial</vt:lpstr>
      <vt:lpstr>Calibri</vt:lpstr>
      <vt:lpstr>Calibri Light</vt:lpstr>
      <vt:lpstr>Times New Roman</vt:lpstr>
      <vt:lpstr>Office Theme</vt:lpstr>
      <vt:lpstr>Stimulus Material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Cardiotocography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eola Kosoko</dc:creator>
  <cp:lastModifiedBy>Kosoko, Adeola A</cp:lastModifiedBy>
  <cp:revision>6</cp:revision>
  <dcterms:created xsi:type="dcterms:W3CDTF">2022-01-14T02:22:26Z</dcterms:created>
  <dcterms:modified xsi:type="dcterms:W3CDTF">2022-04-06T21:14:39Z</dcterms:modified>
</cp:coreProperties>
</file>